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-up of a x-ray&#10;&#10;AI-generated content may be incorrect.">
            <a:extLst>
              <a:ext uri="{FF2B5EF4-FFF2-40B4-BE49-F238E27FC236}">
                <a16:creationId xmlns:a16="http://schemas.microsoft.com/office/drawing/2014/main" id="{96434DE6-B0DD-7F04-29A2-46BBFE75D6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6213" y="1638660"/>
            <a:ext cx="1827101" cy="2001838"/>
          </a:xfrm>
          <a:prstGeom prst="rect">
            <a:avLst/>
          </a:prstGeom>
        </p:spPr>
      </p:pic>
      <p:pic>
        <p:nvPicPr>
          <p:cNvPr id="7" name="Picture 6" descr="X-ray of a skeleton&#10;&#10;AI-generated content may be incorrect.">
            <a:extLst>
              <a:ext uri="{FF2B5EF4-FFF2-40B4-BE49-F238E27FC236}">
                <a16:creationId xmlns:a16="http://schemas.microsoft.com/office/drawing/2014/main" id="{C82E6A98-46FC-CC11-FFD1-7F73CB8ADD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7648" y="1638659"/>
            <a:ext cx="1457475" cy="20018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3204EDE-D2C3-5321-5BB7-3AA527F84FAB}"/>
              </a:ext>
            </a:extLst>
          </p:cNvPr>
          <p:cNvSpPr txBox="1"/>
          <p:nvPr/>
        </p:nvSpPr>
        <p:spPr>
          <a:xfrm>
            <a:off x="239963" y="3851920"/>
            <a:ext cx="647811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4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CT imaging of mouse tumors demonstrates bony destruction when tumors are established in para-tibial location.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image of a mouse tumor established in para-tibial location is shown. The para-tibial  tumor location (arrow, left panel) and presence of bony destruction at the tumor site (arrow, right panel) are shown.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237B1C6E-DD23-3509-B15D-C8E70AB82C98}"/>
              </a:ext>
            </a:extLst>
          </p:cNvPr>
          <p:cNvCxnSpPr/>
          <p:nvPr/>
        </p:nvCxnSpPr>
        <p:spPr>
          <a:xfrm flipH="1">
            <a:off x="2704811" y="2020454"/>
            <a:ext cx="231775" cy="4000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8BF72C47-2099-E85A-B1A0-83472A2DDE0F}"/>
              </a:ext>
            </a:extLst>
          </p:cNvPr>
          <p:cNvCxnSpPr/>
          <p:nvPr/>
        </p:nvCxnSpPr>
        <p:spPr>
          <a:xfrm flipH="1">
            <a:off x="4324061" y="2045854"/>
            <a:ext cx="231775" cy="4000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2753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4:44Z</dcterms:modified>
</cp:coreProperties>
</file>